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xlsx" ContentType="application/vnd.openxmlformats-officedocument.spreadsheetml.sheet"/>
  <Override PartName="/ppt/media/image1.wmf" ContentType="image/x-wmf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E591AC-1B03-4C7A-A3C2-D9A5560640A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821EF4-E67C-44A5-8418-953DDB0EE8A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78356D-7BBA-4256-988D-AAA9138A030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8A6D2F-34B2-4812-A00C-0B9037F4B2E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6532C0-3455-4D01-89DC-41BC625BD23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03B7DF-0C32-44E9-AC3E-647ADB8013E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7AE0AD-1BA9-413E-85F2-93E8F0FE255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4E9DA3-1A69-4A81-9C75-BD850E2C82C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1E39CD-B644-4DE2-A1DE-493881B9F3E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FAB129-D461-40C4-AB7E-01B76A186FB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0E7161-0131-441A-AD43-DDB2DAF7B92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D151DC-13EC-44D6-8F44-FEF44ABB0CA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B05A9BE-0C8B-4A61-9383-8E71F6A5C6F6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1.wmf"/><Relationship Id="rId3" Type="http://schemas.openxmlformats.org/officeDocument/2006/relationships/image" Target="../media/image2.pn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912960" y="1882800"/>
          <a:ext cx="7056360" cy="399240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42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912960" y="1882800"/>
                    <a:ext cx="7056360" cy="39924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3" name=""/>
          <p:cNvSpPr/>
          <p:nvPr/>
        </p:nvSpPr>
        <p:spPr>
          <a:xfrm>
            <a:off x="645840" y="609480"/>
            <a:ext cx="789660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Arial"/>
              </a:rPr>
              <a:t>Supplementary Figure 1: Effect of variation on the callous-unemotiona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Arial"/>
              </a:rPr>
              <a:t>dimension of the YPI (considering CD participants only, *, p &lt; .05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 rot="16200000">
            <a:off x="-302400" y="3549960"/>
            <a:ext cx="2526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</a:rPr>
              <a:t>Correct recognition (%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3813480" y="5638680"/>
            <a:ext cx="1954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</a:rPr>
              <a:t>Facial expressio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6248520" y="1447920"/>
            <a:ext cx="136440" cy="136440"/>
          </a:xfrm>
          <a:prstGeom prst="rect">
            <a:avLst/>
          </a:prstGeom>
          <a:blipFill rotWithShape="0">
            <a:blip r:embed="rId3"/>
            <a:srcRect/>
            <a:tile tx="0" ty="0" sx="100000" sy="100000" algn="ctr"/>
          </a:blip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6248520" y="1657440"/>
            <a:ext cx="136440" cy="136440"/>
          </a:xfrm>
          <a:prstGeom prst="rect">
            <a:avLst/>
          </a:prstGeom>
          <a:solidFill>
            <a:srgbClr val="80808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6366240" y="1371600"/>
            <a:ext cx="2436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Low callous-unemotional (n = 40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6366240" y="1581120"/>
            <a:ext cx="2469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High callous-unemotional (n = 37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0" name=""/>
          <p:cNvGrpSpPr/>
          <p:nvPr/>
        </p:nvGrpSpPr>
        <p:grpSpPr>
          <a:xfrm>
            <a:off x="4010040" y="2600280"/>
            <a:ext cx="476280" cy="76320"/>
            <a:chOff x="4010040" y="2600280"/>
            <a:chExt cx="476280" cy="76320"/>
          </a:xfrm>
        </p:grpSpPr>
        <p:sp>
          <p:nvSpPr>
            <p:cNvPr id="51" name=""/>
            <p:cNvSpPr/>
            <p:nvPr/>
          </p:nvSpPr>
          <p:spPr>
            <a:xfrm>
              <a:off x="4010040" y="2600280"/>
              <a:ext cx="4744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4010040" y="2600280"/>
              <a:ext cx="0" cy="763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520" bIns="29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4486320" y="2600280"/>
              <a:ext cx="0" cy="763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520" bIns="29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4" name=""/>
          <p:cNvSpPr/>
          <p:nvPr/>
        </p:nvSpPr>
        <p:spPr>
          <a:xfrm>
            <a:off x="4105440" y="2338560"/>
            <a:ext cx="269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5" name=""/>
          <p:cNvGrpSpPr/>
          <p:nvPr/>
        </p:nvGrpSpPr>
        <p:grpSpPr>
          <a:xfrm>
            <a:off x="6035760" y="2247840"/>
            <a:ext cx="476280" cy="76320"/>
            <a:chOff x="6035760" y="2247840"/>
            <a:chExt cx="476280" cy="76320"/>
          </a:xfrm>
        </p:grpSpPr>
        <p:sp>
          <p:nvSpPr>
            <p:cNvPr id="56" name=""/>
            <p:cNvSpPr/>
            <p:nvPr/>
          </p:nvSpPr>
          <p:spPr>
            <a:xfrm>
              <a:off x="6035760" y="2247840"/>
              <a:ext cx="4744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6035760" y="2247840"/>
              <a:ext cx="0" cy="763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520" bIns="29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6512040" y="2247840"/>
              <a:ext cx="0" cy="763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520" bIns="29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9" name=""/>
          <p:cNvSpPr/>
          <p:nvPr/>
        </p:nvSpPr>
        <p:spPr>
          <a:xfrm>
            <a:off x="6127920" y="1971720"/>
            <a:ext cx="269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2-08T18:34:23Z</dcterms:created>
  <dc:creator>Graeme Fairchild</dc:creator>
  <dc:description/>
  <dc:language>en-US</dc:language>
  <cp:lastModifiedBy>Graeme Fairchild</cp:lastModifiedBy>
  <dcterms:modified xsi:type="dcterms:W3CDTF">2008-11-18T14:20:51Z</dcterms:modified>
  <cp:revision>3</cp:revision>
  <dc:subject/>
  <dc:title>Slide 1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_AdHocReviewCycleID">
    <vt:r8>-587817553</vt:r8>
  </property>
  <property fmtid="{D5CDD505-2E9C-101B-9397-08002B2CF9AE}" pid="3" name="_AuthorEmail">
    <vt:lpwstr>gff22@cam.ac.uk</vt:lpwstr>
  </property>
  <property fmtid="{D5CDD505-2E9C-101B-9397-08002B2CF9AE}" pid="4" name="_AuthorEmailDisplayName">
    <vt:lpwstr>Graeme Fairchild</vt:lpwstr>
  </property>
  <property fmtid="{D5CDD505-2E9C-101B-9397-08002B2CF9AE}" pid="5" name="_EmailSubject">
    <vt:lpwstr>Corrections to proof of JCPP 2020</vt:lpwstr>
  </property>
</Properties>
</file>